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94"/>
  </p:normalViewPr>
  <p:slideViewPr>
    <p:cSldViewPr snapToGrid="0">
      <p:cViewPr varScale="1">
        <p:scale>
          <a:sx n="121" d="100"/>
          <a:sy n="121" d="100"/>
        </p:scale>
        <p:origin x="3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6EEEDF-E1A5-5F55-DD06-ECC45657B2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DDB582C-C765-D343-38B5-B596264922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B8F50F-9D3C-9B3B-BDF2-0DF55834F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A3C356-1B23-D6DF-C331-A3630F172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6029F8-7DA7-E341-0527-852E800A0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551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FD8FB7-EF4E-0D1C-E1FE-63C2BF4D6E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E88F304-507E-E206-00D0-167809790F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B2166F-97D2-F3F5-DCFB-60293B728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C9C562-7A62-FBD6-8F20-764BC70CA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BD7688-9254-AE65-0773-3619C14F0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4533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D1CFD02-77C6-8B7D-ACD7-62CF26B781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EC162F1-5ACF-F3B7-DE34-D5B838FDEA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69F300-8992-5C6E-0175-F04075ED75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64BC57-B6A1-F448-9219-C1381D6959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D0EAB4-0227-F0D9-B554-C8D7A37E2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379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0F3D99-A521-41C7-0BA1-D2E668B1B5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3F7BE4-2EE8-9F39-CD9C-F84AC5F81E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7CD311-2B21-F264-7F65-E656B3607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0799BFD-BF29-BB58-6361-A913A98B7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4F8736-BCE7-48A0-6A36-3C74023DE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8250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8E23F0-8BFD-8A5E-CD87-783048A1AA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9DCE22A-1850-1AC3-F7D4-8C9B3ABCA7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64D1F6-777D-2774-AD83-CADDE03CF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4BC201-58B4-EBA4-235C-A48E9E23F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B29BB92-F1C8-DC96-FBAE-2C044ECA1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16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9C1A99-EF83-0C7F-3949-D8B222B084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B45F89C-0F1A-1592-DC1E-F932FFA479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3269D5A-B617-035F-5D86-4247B5ACF9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5337E13-3CD4-ADE1-8050-CEA4256D3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F5C95D-BD96-D6B3-9D0B-42DAE8165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26263B1-B25F-7714-1DB9-6A3D2FC0A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1297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1D6BCD-F643-1D3A-AF52-22F751B13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75AE950-B5EF-6F7D-CA46-03DC5D763C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18674B9-1DCA-6D70-B340-D6582EB623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9F064E1-CE83-5318-57ED-B6B996C178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7E9915F-2223-A151-BDBD-9CA4C93F61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73C6D64-F93C-C1C6-2B32-A796D2CC1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EED5F54-CC94-FEBB-A5D5-FF36D983E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C71F311-C5CD-2BDF-9570-FB1509EA2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079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8FD6D2-DBEE-68C9-8B66-F6E073CC08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BC286E6-7A84-F96F-2A95-7FDD72C3C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67A3628-0C7F-6290-677E-AB08A7104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AD195FC-FD3B-9075-9330-2F5A09B95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819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6A8471B-8680-3B15-2397-83A438E34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46A47EA-2E8E-DF4D-1D04-196DBFB92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E75AC86-776C-556A-83C7-2F2E494533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491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10EB06-20B9-1B18-9803-55B5BCF252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7E1EA82-4ECA-535F-6A53-E043D11644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93E8C36-E961-5BAC-BD85-B4DA99C812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782CBAA-8EB6-3803-6EE1-68E41CDA5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7C67C74-E80A-7DED-1776-4A18FE5BC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9BD41E4-027D-8BDD-8F7E-226F9647F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0843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240FB5-B80F-C334-C6E3-ADE9D07BE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A910895-E16F-DAFF-ADB9-193C6EFAB3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652B800-116C-2469-4CA2-B4649898FA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329221E-450F-0629-FCD7-3FC3777CB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66C8047-C8E1-9A2E-3585-EDEB6FDA7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0DC572-35B6-56E0-A533-CD11DC923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7709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919A5E3-814D-0DCA-1FE0-08667F730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721014-2430-09F8-3E8F-3691FE08A4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60E585-2590-B51B-FF06-7A8BF641B8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AB09D-9518-A24D-94CD-4D44D6582403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41FDCE-1E32-620F-ABA0-09DF1C174C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CD90AA-7617-AA42-E249-549221DD8D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8545A-A42F-2744-8B87-E9F593C99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1448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5DA6B247-3C45-A9F9-D2F0-4BFA29190E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1115777"/>
              </p:ext>
            </p:extLst>
          </p:nvPr>
        </p:nvGraphicFramePr>
        <p:xfrm>
          <a:off x="2582426" y="399393"/>
          <a:ext cx="5528446" cy="6027369"/>
        </p:xfrm>
        <a:graphic>
          <a:graphicData uri="http://schemas.openxmlformats.org/drawingml/2006/table">
            <a:tbl>
              <a:tblPr firstRow="1" firstCol="1" bandRow="1"/>
              <a:tblGrid>
                <a:gridCol w="439306">
                  <a:extLst>
                    <a:ext uri="{9D8B030D-6E8A-4147-A177-3AD203B41FA5}">
                      <a16:colId xmlns:a16="http://schemas.microsoft.com/office/drawing/2014/main" val="150821048"/>
                    </a:ext>
                  </a:extLst>
                </a:gridCol>
                <a:gridCol w="269444">
                  <a:extLst>
                    <a:ext uri="{9D8B030D-6E8A-4147-A177-3AD203B41FA5}">
                      <a16:colId xmlns:a16="http://schemas.microsoft.com/office/drawing/2014/main" val="2856949471"/>
                    </a:ext>
                  </a:extLst>
                </a:gridCol>
                <a:gridCol w="807606">
                  <a:extLst>
                    <a:ext uri="{9D8B030D-6E8A-4147-A177-3AD203B41FA5}">
                      <a16:colId xmlns:a16="http://schemas.microsoft.com/office/drawing/2014/main" val="3682125091"/>
                    </a:ext>
                  </a:extLst>
                </a:gridCol>
                <a:gridCol w="511096">
                  <a:extLst>
                    <a:ext uri="{9D8B030D-6E8A-4147-A177-3AD203B41FA5}">
                      <a16:colId xmlns:a16="http://schemas.microsoft.com/office/drawing/2014/main" val="2262726092"/>
                    </a:ext>
                  </a:extLst>
                </a:gridCol>
                <a:gridCol w="550701">
                  <a:extLst>
                    <a:ext uri="{9D8B030D-6E8A-4147-A177-3AD203B41FA5}">
                      <a16:colId xmlns:a16="http://schemas.microsoft.com/office/drawing/2014/main" val="4157194605"/>
                    </a:ext>
                  </a:extLst>
                </a:gridCol>
                <a:gridCol w="326594">
                  <a:extLst>
                    <a:ext uri="{9D8B030D-6E8A-4147-A177-3AD203B41FA5}">
                      <a16:colId xmlns:a16="http://schemas.microsoft.com/office/drawing/2014/main" val="222174687"/>
                    </a:ext>
                  </a:extLst>
                </a:gridCol>
                <a:gridCol w="321563">
                  <a:extLst>
                    <a:ext uri="{9D8B030D-6E8A-4147-A177-3AD203B41FA5}">
                      <a16:colId xmlns:a16="http://schemas.microsoft.com/office/drawing/2014/main" val="2251592793"/>
                    </a:ext>
                  </a:extLst>
                </a:gridCol>
                <a:gridCol w="644616">
                  <a:extLst>
                    <a:ext uri="{9D8B030D-6E8A-4147-A177-3AD203B41FA5}">
                      <a16:colId xmlns:a16="http://schemas.microsoft.com/office/drawing/2014/main" val="1767730320"/>
                    </a:ext>
                  </a:extLst>
                </a:gridCol>
                <a:gridCol w="546538">
                  <a:extLst>
                    <a:ext uri="{9D8B030D-6E8A-4147-A177-3AD203B41FA5}">
                      <a16:colId xmlns:a16="http://schemas.microsoft.com/office/drawing/2014/main" val="3699657505"/>
                    </a:ext>
                  </a:extLst>
                </a:gridCol>
                <a:gridCol w="662151">
                  <a:extLst>
                    <a:ext uri="{9D8B030D-6E8A-4147-A177-3AD203B41FA5}">
                      <a16:colId xmlns:a16="http://schemas.microsoft.com/office/drawing/2014/main" val="2803741925"/>
                    </a:ext>
                  </a:extLst>
                </a:gridCol>
                <a:gridCol w="448831">
                  <a:extLst>
                    <a:ext uri="{9D8B030D-6E8A-4147-A177-3AD203B41FA5}">
                      <a16:colId xmlns:a16="http://schemas.microsoft.com/office/drawing/2014/main" val="516816178"/>
                    </a:ext>
                  </a:extLst>
                </a:gridCol>
              </a:tblGrid>
              <a:tr h="549641"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ample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ex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Extent of U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Disease duration before RPC, y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use of RP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M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E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Observation period, y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urgical procedure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Development of pouch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PDAI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b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8881705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eft-sided 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.7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Refractory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7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4.77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5224469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eft-sided 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8.0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.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94991091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0.9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.44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8665469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4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2.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4.77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C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6175551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6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Refractory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9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4.36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3238762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6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8.7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4.29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0915339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7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4.8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Stenos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4.2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8166178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8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6.9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.9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C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2093095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9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0.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.7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C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1715979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10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6.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Refractory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8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.47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8387655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1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7.6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.3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C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4212663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1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eft-sided 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4.6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.88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C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1552409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13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Left-sided 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.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.4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0719842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14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.0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Refractory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8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.9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4135203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15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32.4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.5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2592226"/>
                  </a:ext>
                </a:extLst>
              </a:tr>
              <a:tr h="342358"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UC 16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M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Pancolitis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4.9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CAC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1.41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IPACA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ja-JP" sz="8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　</a:t>
                      </a:r>
                      <a:endParaRPr lang="ja-JP" sz="8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5028" marR="4502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69236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46026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13</Words>
  <Application>Microsoft Macintosh PowerPoint</Application>
  <PresentationFormat>ワイド画面</PresentationFormat>
  <Paragraphs>17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梨紗 中西</dc:creator>
  <cp:lastModifiedBy>梨紗 中西</cp:lastModifiedBy>
  <cp:revision>4</cp:revision>
  <dcterms:created xsi:type="dcterms:W3CDTF">2024-06-18T01:51:46Z</dcterms:created>
  <dcterms:modified xsi:type="dcterms:W3CDTF">2024-07-06T09:12:25Z</dcterms:modified>
</cp:coreProperties>
</file>